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939" y="5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DB8D9E1-D3D0-4A14-B1AF-24C8339B3423}" type="datetimeFigureOut">
              <a:rPr lang="zh-CN" altLang="en-US" smtClean="0"/>
              <a:t>2025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03F705-238A-4529-8A56-FF8B5C1D55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17107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CD13F9-4267-486D-8006-6E53ED32D09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65708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09AA04-1126-9315-1815-AD697433512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62CBFBF-3586-2963-C680-36FCDA252F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0D71A7-B267-9D7C-FA78-2F3E0FF3D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47752-523F-4D6C-85A7-D49F06C6D1B0}" type="datetimeFigureOut">
              <a:rPr lang="zh-CN" altLang="en-US" smtClean="0"/>
              <a:t>2025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768223D-9D04-7535-B2C7-4CBDB3CF1A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2AA3CB3-BB09-F6C2-BEB0-2C265B257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D0238-80D2-459B-8C4A-B1AE29508C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1316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0AF00C-3353-A0CE-4B38-96ED414DB5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72A12A9-B6DC-7E4D-BF7A-D3F821C2FE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197E82-AF1E-5961-09A9-D72BAC6955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47752-523F-4D6C-85A7-D49F06C6D1B0}" type="datetimeFigureOut">
              <a:rPr lang="zh-CN" altLang="en-US" smtClean="0"/>
              <a:t>2025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CA22F6-4C04-E720-A437-0CBD1352DC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6B83BB-DD62-ADB2-1E8D-A45A58C2EA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D0238-80D2-459B-8C4A-B1AE29508C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5001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561332F-D52D-7A89-FB0F-02788FF252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E15B738-A21E-F398-F991-4E3B4E0DCE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2359B7A-E755-ED19-5BAD-F3680075C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47752-523F-4D6C-85A7-D49F06C6D1B0}" type="datetimeFigureOut">
              <a:rPr lang="zh-CN" altLang="en-US" smtClean="0"/>
              <a:t>2025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5F74696-A766-97A7-925E-1EE8D93662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4DB960-C2B7-26B9-05F4-353C83CF3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D0238-80D2-459B-8C4A-B1AE29508C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4409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1CB8B9-83B2-97AC-2945-F2382FCA74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5F34B12-5FBD-F9A6-80F3-ADB9C79A6F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149EF8C-D185-DFA2-DFCD-138C4E9E6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47752-523F-4D6C-85A7-D49F06C6D1B0}" type="datetimeFigureOut">
              <a:rPr lang="zh-CN" altLang="en-US" smtClean="0"/>
              <a:t>2025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5510B71-1B21-07C7-9B09-A75DA14FF0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C349331-058B-1548-F979-06A4F0E87B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D0238-80D2-459B-8C4A-B1AE29508C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6685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E80D39-C71A-BCA8-CA3A-7316D31176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054050F-912D-3531-ADED-EE77F58674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289A03E-D35B-C0EC-14AC-3DFD4A026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47752-523F-4D6C-85A7-D49F06C6D1B0}" type="datetimeFigureOut">
              <a:rPr lang="zh-CN" altLang="en-US" smtClean="0"/>
              <a:t>2025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CFD55B8-F8A5-46F9-8C57-E0029EEC0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D8BB4FB-BA14-52FA-339D-0EB7E2F5C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D0238-80D2-459B-8C4A-B1AE29508C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3847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B47135-29BE-03C8-4FDD-6A0E87E5C9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67C2F47-E511-E6A8-4CE7-0DCEB2CDA8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CB3F855-6246-49B3-3DC8-088187180A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080F19D-80D9-51F0-046C-8079F3F88B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47752-523F-4D6C-85A7-D49F06C6D1B0}" type="datetimeFigureOut">
              <a:rPr lang="zh-CN" altLang="en-US" smtClean="0"/>
              <a:t>2025/6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CF1E919-F41A-8FE0-6349-6891E0BFC1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9F05B07-BE1A-5412-4C30-B968CB6B76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D0238-80D2-459B-8C4A-B1AE29508C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586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20F450-3B96-4A09-800A-98CB9756AA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5D29BC5-06FC-22BD-8C0F-BEBFFEAAEB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4C81D8F-E53B-4F5B-1EDD-B6ED1EB49B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A088190-8F08-A490-2AC0-D8B54A0B64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90955BB-F8C5-B4F0-EB6D-5B6D7860D1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561C6F0-65B3-4242-E90C-542146BD6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47752-523F-4D6C-85A7-D49F06C6D1B0}" type="datetimeFigureOut">
              <a:rPr lang="zh-CN" altLang="en-US" smtClean="0"/>
              <a:t>2025/6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077EBEB-42D5-8BB1-FA64-AE5891C98E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1F687DE-584B-C8A0-B5D6-BB0416FEB9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D0238-80D2-459B-8C4A-B1AE29508C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8365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BAD88A-72AE-5EFF-1A12-F0CF98D7EE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0E6D97F-002A-0D2E-005F-08FD020DA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47752-523F-4D6C-85A7-D49F06C6D1B0}" type="datetimeFigureOut">
              <a:rPr lang="zh-CN" altLang="en-US" smtClean="0"/>
              <a:t>2025/6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BA85066-3947-4708-DCC5-8DECBBDCB3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A750A01-7CEC-144F-6A02-28BE7D05A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D0238-80D2-459B-8C4A-B1AE29508C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70447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DF1C3A4-7960-1982-E182-B5955DFFC7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47752-523F-4D6C-85A7-D49F06C6D1B0}" type="datetimeFigureOut">
              <a:rPr lang="zh-CN" altLang="en-US" smtClean="0"/>
              <a:t>2025/6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C20EF54-F1B7-4551-FE26-AA1C42B20C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F925FE7-71D0-98E6-6F62-2E687502A5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D0238-80D2-459B-8C4A-B1AE29508C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05706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4D75E7-6EF5-4CA4-E5CF-05AADC2B19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2627764-B7A8-63E1-EA04-02D30B41BB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8219167-4694-D610-2F96-4E25ECE618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9DB4C04-5456-01E8-5CC2-4FD817A9E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47752-523F-4D6C-85A7-D49F06C6D1B0}" type="datetimeFigureOut">
              <a:rPr lang="zh-CN" altLang="en-US" smtClean="0"/>
              <a:t>2025/6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F77CCE8-DA25-5B04-129D-FEE5FF793F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A60D448-EF5A-06FB-8780-FF150E3938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D0238-80D2-459B-8C4A-B1AE29508C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7153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683402-DC5D-85A9-120F-48E7CE1CF9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4476CFE-2F26-1912-F7B3-5C6282A957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DF0A661-8854-3569-354F-BA3FB05222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3829F53-4B59-F8C6-38D3-B78F2A571A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47752-523F-4D6C-85A7-D49F06C6D1B0}" type="datetimeFigureOut">
              <a:rPr lang="zh-CN" altLang="en-US" smtClean="0"/>
              <a:t>2025/6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882E318-121C-BC1C-9149-F87B22162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123F55C-F9A3-C861-399C-507B14A3B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D0238-80D2-459B-8C4A-B1AE29508C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23960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0457400-FEA3-3F85-6B1B-218B6B78F0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F6930CC-ED5F-75B0-7AE8-D9641D4BC4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A6A41A-C12A-9C31-C8F7-C8782F613E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347752-523F-4D6C-85A7-D49F06C6D1B0}" type="datetimeFigureOut">
              <a:rPr lang="zh-CN" altLang="en-US" smtClean="0"/>
              <a:t>2025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A29D8BA-10A9-9172-4961-FCBEBD981F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A18280C-2DD0-5D0D-C243-13F42A2A987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0D0238-80D2-459B-8C4A-B1AE29508C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7143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 descr="文本&#10;&#10;中度可信度描述已自动生成">
            <a:extLst>
              <a:ext uri="{FF2B5EF4-FFF2-40B4-BE49-F238E27FC236}">
                <a16:creationId xmlns:a16="http://schemas.microsoft.com/office/drawing/2014/main" id="{D3EE04B4-6CFD-CC7F-1BD5-7189C76ADD2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22" t="42462" r="21616" b="20730"/>
          <a:stretch/>
        </p:blipFill>
        <p:spPr>
          <a:xfrm flipH="1">
            <a:off x="7246" y="513454"/>
            <a:ext cx="2493304" cy="2312476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1716A1EA-387C-7A7B-3899-9A05B3FD0720}"/>
              </a:ext>
            </a:extLst>
          </p:cNvPr>
          <p:cNvSpPr/>
          <p:nvPr/>
        </p:nvSpPr>
        <p:spPr>
          <a:xfrm rot="5400000">
            <a:off x="-864247" y="1377701"/>
            <a:ext cx="2312478" cy="583984"/>
          </a:xfrm>
          <a:prstGeom prst="rect">
            <a:avLst/>
          </a:prstGeom>
          <a:noFill/>
          <a:ln w="63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FF15AF4E-FC8F-A5A9-BE75-D7F918A4D510}"/>
              </a:ext>
            </a:extLst>
          </p:cNvPr>
          <p:cNvSpPr txBox="1"/>
          <p:nvPr/>
        </p:nvSpPr>
        <p:spPr>
          <a:xfrm>
            <a:off x="583984" y="1811759"/>
            <a:ext cx="173006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0" i="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omassie Brilliant Blue 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6F17E6D4-8FB7-631D-33E5-37A7EA9B3D3A}"/>
              </a:ext>
            </a:extLst>
          </p:cNvPr>
          <p:cNvSpPr txBox="1"/>
          <p:nvPr/>
        </p:nvSpPr>
        <p:spPr>
          <a:xfrm>
            <a:off x="7246" y="1289325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zh-CN" altLang="en-US" sz="5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2E6B80A-AE5E-2F5A-BFC7-4A422C39A776}"/>
              </a:ext>
            </a:extLst>
          </p:cNvPr>
          <p:cNvSpPr txBox="1"/>
          <p:nvPr/>
        </p:nvSpPr>
        <p:spPr>
          <a:xfrm>
            <a:off x="78472" y="967298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40</a:t>
            </a:r>
            <a:endParaRPr lang="zh-CN" altLang="en-US" sz="5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2552062-2275-D31D-73C4-B0D2AA60B374}"/>
              </a:ext>
            </a:extLst>
          </p:cNvPr>
          <p:cNvSpPr txBox="1"/>
          <p:nvPr/>
        </p:nvSpPr>
        <p:spPr>
          <a:xfrm>
            <a:off x="78472" y="749627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80</a:t>
            </a:r>
            <a:endParaRPr lang="zh-CN" altLang="en-US" sz="5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" name="组合 30">
            <a:extLst>
              <a:ext uri="{FF2B5EF4-FFF2-40B4-BE49-F238E27FC236}">
                <a16:creationId xmlns:a16="http://schemas.microsoft.com/office/drawing/2014/main" id="{BE747F5D-4696-F96E-11EC-C597E6A71123}"/>
              </a:ext>
            </a:extLst>
          </p:cNvPr>
          <p:cNvGrpSpPr/>
          <p:nvPr/>
        </p:nvGrpSpPr>
        <p:grpSpPr>
          <a:xfrm>
            <a:off x="5344232" y="528410"/>
            <a:ext cx="2646256" cy="2323180"/>
            <a:chOff x="5571307" y="205898"/>
            <a:chExt cx="2646256" cy="2323180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CB380066-2C78-EB9C-C518-6960DF055A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8451" t="7073" r="39532" b="515"/>
            <a:stretch/>
          </p:blipFill>
          <p:spPr>
            <a:xfrm>
              <a:off x="6894435" y="205898"/>
              <a:ext cx="1323128" cy="2321713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A1D14F86-0437-9C1A-694D-B267663461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8910" t="7113" r="40298"/>
            <a:stretch/>
          </p:blipFill>
          <p:spPr>
            <a:xfrm>
              <a:off x="5571307" y="207365"/>
              <a:ext cx="1323128" cy="2321713"/>
            </a:xfrm>
            <a:prstGeom prst="rect">
              <a:avLst/>
            </a:prstGeom>
          </p:spPr>
        </p:pic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858D9D9A-EFC2-AFA1-E1CD-EF58C5A9B437}"/>
                </a:ext>
              </a:extLst>
            </p:cNvPr>
            <p:cNvSpPr/>
            <p:nvPr/>
          </p:nvSpPr>
          <p:spPr>
            <a:xfrm>
              <a:off x="5635792" y="436171"/>
              <a:ext cx="2427611" cy="3471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6352234F-BBCB-1519-A2F3-DA7AA6355063}"/>
                </a:ext>
              </a:extLst>
            </p:cNvPr>
            <p:cNvSpPr txBox="1"/>
            <p:nvPr/>
          </p:nvSpPr>
          <p:spPr>
            <a:xfrm>
              <a:off x="6854242" y="783351"/>
              <a:ext cx="52931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INK1/TOM</a:t>
              </a:r>
              <a:endParaRPr lang="zh-CN" altLang="en-US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" name="组合 29">
            <a:extLst>
              <a:ext uri="{FF2B5EF4-FFF2-40B4-BE49-F238E27FC236}">
                <a16:creationId xmlns:a16="http://schemas.microsoft.com/office/drawing/2014/main" id="{A374C266-9EA7-D4CA-562B-B4C6AC5F85A1}"/>
              </a:ext>
            </a:extLst>
          </p:cNvPr>
          <p:cNvGrpSpPr/>
          <p:nvPr/>
        </p:nvGrpSpPr>
        <p:grpSpPr>
          <a:xfrm>
            <a:off x="2571175" y="532383"/>
            <a:ext cx="2637774" cy="2327216"/>
            <a:chOff x="2840391" y="205604"/>
            <a:chExt cx="2637774" cy="2327216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4F16284C-F39E-5FBA-0A0E-B847E48241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38588" t="6270" r="38339" b="2559"/>
            <a:stretch/>
          </p:blipFill>
          <p:spPr>
            <a:xfrm>
              <a:off x="4155036" y="205604"/>
              <a:ext cx="1323129" cy="2327216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47035098-0DA8-217B-0FC0-D296E70758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44027" t="29664" r="43836" b="26670"/>
            <a:stretch/>
          </p:blipFill>
          <p:spPr>
            <a:xfrm>
              <a:off x="2840391" y="205604"/>
              <a:ext cx="1323128" cy="2321714"/>
            </a:xfrm>
            <a:prstGeom prst="rect">
              <a:avLst/>
            </a:prstGeom>
          </p:spPr>
        </p:pic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8820FA74-C263-CEC1-19E4-9C7535F4C28F}"/>
                </a:ext>
              </a:extLst>
            </p:cNvPr>
            <p:cNvSpPr/>
            <p:nvPr/>
          </p:nvSpPr>
          <p:spPr>
            <a:xfrm>
              <a:off x="3073253" y="368741"/>
              <a:ext cx="2352348" cy="3471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A6F28556-0139-DE00-3153-EEE5050CCF0E}"/>
                </a:ext>
              </a:extLst>
            </p:cNvPr>
            <p:cNvSpPr txBox="1"/>
            <p:nvPr/>
          </p:nvSpPr>
          <p:spPr>
            <a:xfrm>
              <a:off x="4163519" y="712102"/>
              <a:ext cx="52931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INK1/TOM</a:t>
              </a:r>
              <a:endParaRPr lang="zh-CN" altLang="en-US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9" name="图片 18">
            <a:extLst>
              <a:ext uri="{FF2B5EF4-FFF2-40B4-BE49-F238E27FC236}">
                <a16:creationId xmlns:a16="http://schemas.microsoft.com/office/drawing/2014/main" id="{56C9B66C-66D5-8AF9-BB4F-54ED7C55477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9150" t="26132" r="35849" b="30646"/>
          <a:stretch/>
        </p:blipFill>
        <p:spPr>
          <a:xfrm>
            <a:off x="2889830" y="3254221"/>
            <a:ext cx="2905203" cy="2216758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DB383CC1-AC0A-2773-FD6F-673693529461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0077" t="23662" r="35609" b="28524"/>
          <a:stretch/>
        </p:blipFill>
        <p:spPr>
          <a:xfrm>
            <a:off x="7246" y="3119612"/>
            <a:ext cx="2960501" cy="2398589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1FD1F25D-09BA-5BD3-774B-9F8D77C5F7A0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32274" t="32210" r="35297" b="27538"/>
          <a:stretch/>
        </p:blipFill>
        <p:spPr>
          <a:xfrm>
            <a:off x="6084350" y="3254221"/>
            <a:ext cx="2451870" cy="2216758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A48D413F-D5BC-4D35-0983-DA7E3748B3E4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32549" t="32210" r="35022" b="27538"/>
          <a:stretch/>
        </p:blipFill>
        <p:spPr>
          <a:xfrm>
            <a:off x="8537538" y="3206999"/>
            <a:ext cx="2451869" cy="2263980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C68D9EC7-7CFD-5620-E8CC-434A68A2AE21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20140" t="9728" r="16731"/>
          <a:stretch/>
        </p:blipFill>
        <p:spPr>
          <a:xfrm>
            <a:off x="10112370" y="494981"/>
            <a:ext cx="2015002" cy="2281270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DDF28925-AA56-10CB-BDDA-A190FD701BCC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20206" t="9728" r="16666"/>
          <a:stretch/>
        </p:blipFill>
        <p:spPr>
          <a:xfrm>
            <a:off x="8097368" y="494981"/>
            <a:ext cx="2015002" cy="2281270"/>
          </a:xfrm>
          <a:prstGeom prst="rect">
            <a:avLst/>
          </a:prstGeom>
        </p:spPr>
      </p:pic>
      <p:sp>
        <p:nvSpPr>
          <p:cNvPr id="32" name="矩形 31">
            <a:extLst>
              <a:ext uri="{FF2B5EF4-FFF2-40B4-BE49-F238E27FC236}">
                <a16:creationId xmlns:a16="http://schemas.microsoft.com/office/drawing/2014/main" id="{AEA3EC47-AA37-2BC9-2983-8C5706FFB7E5}"/>
              </a:ext>
            </a:extLst>
          </p:cNvPr>
          <p:cNvSpPr/>
          <p:nvPr/>
        </p:nvSpPr>
        <p:spPr>
          <a:xfrm>
            <a:off x="368936" y="3476528"/>
            <a:ext cx="4866854" cy="164547"/>
          </a:xfrm>
          <a:prstGeom prst="rect">
            <a:avLst/>
          </a:prstGeom>
          <a:noFill/>
          <a:ln w="63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9283782F-24D2-BF4C-910C-F1744170847E}"/>
              </a:ext>
            </a:extLst>
          </p:cNvPr>
          <p:cNvSpPr txBox="1"/>
          <p:nvPr/>
        </p:nvSpPr>
        <p:spPr>
          <a:xfrm>
            <a:off x="2963836" y="3259722"/>
            <a:ext cx="109511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NK1/TOM</a:t>
            </a:r>
            <a:endParaRPr lang="zh-CN" altLang="en-US" sz="5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8A3FEFFF-5104-7281-ED3E-37EEE69ECDF6}"/>
              </a:ext>
            </a:extLst>
          </p:cNvPr>
          <p:cNvSpPr txBox="1"/>
          <p:nvPr/>
        </p:nvSpPr>
        <p:spPr>
          <a:xfrm>
            <a:off x="147351" y="3884059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zh-CN" altLang="en-US" sz="5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7797683F-509D-552B-8A12-D04E4DABE6AB}"/>
              </a:ext>
            </a:extLst>
          </p:cNvPr>
          <p:cNvSpPr txBox="1"/>
          <p:nvPr/>
        </p:nvSpPr>
        <p:spPr>
          <a:xfrm>
            <a:off x="152478" y="3562032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40</a:t>
            </a:r>
            <a:endParaRPr lang="zh-CN" altLang="en-US" sz="5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ACF2B286-7FB2-1133-A90D-50C405FB10EF}"/>
              </a:ext>
            </a:extLst>
          </p:cNvPr>
          <p:cNvSpPr txBox="1"/>
          <p:nvPr/>
        </p:nvSpPr>
        <p:spPr>
          <a:xfrm>
            <a:off x="152478" y="3344361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80</a:t>
            </a:r>
            <a:endParaRPr lang="zh-CN" altLang="en-US" sz="5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47CB3EBF-E15F-980A-36AC-49D73797F08A}"/>
              </a:ext>
            </a:extLst>
          </p:cNvPr>
          <p:cNvSpPr/>
          <p:nvPr/>
        </p:nvSpPr>
        <p:spPr>
          <a:xfrm>
            <a:off x="6699978" y="4163246"/>
            <a:ext cx="3881723" cy="271043"/>
          </a:xfrm>
          <a:prstGeom prst="rect">
            <a:avLst/>
          </a:prstGeom>
          <a:noFill/>
          <a:ln w="63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AF4EE57C-70CC-0AE1-3695-D758C1E8FD92}"/>
              </a:ext>
            </a:extLst>
          </p:cNvPr>
          <p:cNvSpPr txBox="1"/>
          <p:nvPr/>
        </p:nvSpPr>
        <p:spPr>
          <a:xfrm>
            <a:off x="8536220" y="4434289"/>
            <a:ext cx="873443" cy="1727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5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B56093BF-5356-144B-D226-D14B5F440E44}"/>
              </a:ext>
            </a:extLst>
          </p:cNvPr>
          <p:cNvSpPr/>
          <p:nvPr/>
        </p:nvSpPr>
        <p:spPr>
          <a:xfrm>
            <a:off x="8116046" y="1540716"/>
            <a:ext cx="3881723" cy="271043"/>
          </a:xfrm>
          <a:prstGeom prst="rect">
            <a:avLst/>
          </a:prstGeom>
          <a:noFill/>
          <a:ln w="63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88E62F82-3B2E-E3F9-1A52-EB0FE7126BCA}"/>
              </a:ext>
            </a:extLst>
          </p:cNvPr>
          <p:cNvSpPr txBox="1"/>
          <p:nvPr/>
        </p:nvSpPr>
        <p:spPr>
          <a:xfrm>
            <a:off x="10056907" y="1387021"/>
            <a:ext cx="873443" cy="1727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5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7ED317F-799A-8D14-B5EA-346FB247263D}"/>
              </a:ext>
            </a:extLst>
          </p:cNvPr>
          <p:cNvSpPr txBox="1"/>
          <p:nvPr/>
        </p:nvSpPr>
        <p:spPr>
          <a:xfrm>
            <a:off x="368936" y="3136406"/>
            <a:ext cx="2064989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5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altLang="zh-CN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altLang="zh-CN" sz="5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altLang="zh-CN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ISO              </a:t>
            </a:r>
            <a:r>
              <a:rPr lang="en-US" altLang="zh-CN" sz="5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O</a:t>
            </a:r>
            <a:r>
              <a:rPr lang="en-US" altLang="zh-CN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CCCP    </a:t>
            </a:r>
            <a:r>
              <a:rPr lang="en-US" altLang="zh-CN" sz="5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CP</a:t>
            </a:r>
            <a:r>
              <a:rPr lang="en-US" altLang="zh-CN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I+C       </a:t>
            </a:r>
            <a:r>
              <a:rPr lang="en-US" altLang="zh-CN" sz="5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+C</a:t>
            </a:r>
            <a:endParaRPr lang="zh-CN" altLang="en-US" sz="5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BF36DA3-17D8-A92E-3CD9-4D062C9DB3F5}"/>
              </a:ext>
            </a:extLst>
          </p:cNvPr>
          <p:cNvSpPr txBox="1"/>
          <p:nvPr/>
        </p:nvSpPr>
        <p:spPr>
          <a:xfrm>
            <a:off x="368936" y="345772"/>
            <a:ext cx="1027845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5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altLang="zh-CN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ISO CCCP ISO+CCCP</a:t>
            </a:r>
            <a:endParaRPr lang="zh-CN" altLang="en-US" sz="5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5BFBCCB-B2C5-5663-E075-2010542ACF4D}"/>
              </a:ext>
            </a:extLst>
          </p:cNvPr>
          <p:cNvSpPr txBox="1"/>
          <p:nvPr/>
        </p:nvSpPr>
        <p:spPr>
          <a:xfrm>
            <a:off x="1272706" y="359133"/>
            <a:ext cx="1027845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5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altLang="zh-CN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ISO CCCP ISO+CCCP</a:t>
            </a:r>
            <a:endParaRPr lang="zh-CN" altLang="en-US" sz="5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50980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5</Words>
  <Application>Microsoft Office PowerPoint</Application>
  <PresentationFormat>宽屏</PresentationFormat>
  <Paragraphs>1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ngli</dc:creator>
  <cp:lastModifiedBy>angli</cp:lastModifiedBy>
  <cp:revision>9</cp:revision>
  <dcterms:created xsi:type="dcterms:W3CDTF">2025-06-16T11:13:03Z</dcterms:created>
  <dcterms:modified xsi:type="dcterms:W3CDTF">2025-06-22T14:04:02Z</dcterms:modified>
</cp:coreProperties>
</file>